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4674"/>
  </p:normalViewPr>
  <p:slideViewPr>
    <p:cSldViewPr snapToGrid="0" snapToObjects="1">
      <p:cViewPr varScale="1">
        <p:scale>
          <a:sx n="114" d="100"/>
          <a:sy n="114" d="100"/>
        </p:scale>
        <p:origin x="43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3C9192B-2405-E84A-840C-75B0DE83AC0E}" type="datetimeFigureOut">
              <a:rPr lang="en-US" smtClean="0"/>
              <a:t>3/23/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409EF34-00B6-8046-8150-6190AAFDC2A2}" type="slidenum">
              <a:rPr lang="en-US" smtClean="0"/>
              <a:t>‹Nr.›</a:t>
            </a:fld>
            <a:endParaRPr lang="en-US"/>
          </a:p>
        </p:txBody>
      </p:sp>
    </p:spTree>
    <p:extLst>
      <p:ext uri="{BB962C8B-B14F-4D97-AF65-F5344CB8AC3E}">
        <p14:creationId xmlns:p14="http://schemas.microsoft.com/office/powerpoint/2010/main" val="11498125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normAutofit/>
          </a:bodyPr>
          <a:lstStyle/>
          <a:p>
            <a:endParaRPr lang="de-DE"/>
          </a:p>
        </p:txBody>
      </p:sp>
      <p:sp>
        <p:nvSpPr>
          <p:cNvPr id="4" name="Foliennummernplatzhalter 3"/>
          <p:cNvSpPr>
            <a:spLocks noGrp="1"/>
          </p:cNvSpPr>
          <p:nvPr>
            <p:ph type="sldNum" sz="quarter" idx="10"/>
          </p:nvPr>
        </p:nvSpPr>
        <p:spPr/>
        <p:txBody>
          <a:bodyPr/>
          <a:lstStyle/>
          <a:p>
            <a:fld id="{F1A56315-54F5-4662-85BE-F9D5F844A593}" type="slidenum">
              <a:rPr lang="de-DE" smtClean="0"/>
              <a:pPr/>
              <a:t>1</a:t>
            </a:fld>
            <a:endParaRPr lang="de-DE"/>
          </a:p>
        </p:txBody>
      </p:sp>
    </p:spTree>
    <p:extLst>
      <p:ext uri="{BB962C8B-B14F-4D97-AF65-F5344CB8AC3E}">
        <p14:creationId xmlns:p14="http://schemas.microsoft.com/office/powerpoint/2010/main" val="32060596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4E27C2-9DF0-7444-B1F2-07D6E3D6B40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B6B0541-E45F-0946-A9B1-BC5E5AAE912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B7366A8-1549-CD49-B126-8F39935A9FEF}"/>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5" name="Footer Placeholder 4">
            <a:extLst>
              <a:ext uri="{FF2B5EF4-FFF2-40B4-BE49-F238E27FC236}">
                <a16:creationId xmlns:a16="http://schemas.microsoft.com/office/drawing/2014/main" id="{7C17DF8F-FB72-3549-BF9F-44C0C549D4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3F8C5C-2E6F-004D-87A7-7D528CFBEF17}"/>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10078728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C1C99A-D5F1-8F40-88EC-4AA6FF983B8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73218E3-E87D-3A48-B179-DEC6571BD58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6A2AC58-67D0-764E-A832-4DE17B9383C0}"/>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5" name="Footer Placeholder 4">
            <a:extLst>
              <a:ext uri="{FF2B5EF4-FFF2-40B4-BE49-F238E27FC236}">
                <a16:creationId xmlns:a16="http://schemas.microsoft.com/office/drawing/2014/main" id="{B22B5955-7C88-2C42-92D1-CE16810B17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82F6EC7-DE1C-FE49-91C2-A6192DC9CB30}"/>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27078066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5B25D52-8317-384B-81EE-BFAA0EAFD7F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776CAD5-8C66-9646-A095-41414F7F538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15DA48-887D-D14F-A19F-D254EDE3E87F}"/>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5" name="Footer Placeholder 4">
            <a:extLst>
              <a:ext uri="{FF2B5EF4-FFF2-40B4-BE49-F238E27FC236}">
                <a16:creationId xmlns:a16="http://schemas.microsoft.com/office/drawing/2014/main" id="{8825E133-12AE-1246-B46E-7BBBADEEEE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40BC79-CC63-5F4E-8C1A-7ED1963C5EB5}"/>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7697557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3648AC-724C-E749-AD84-A8277D000DC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0584DD5-6964-4D42-9016-E2B5AE36234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2FA350-5405-E046-B274-47FC0650125A}"/>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5" name="Footer Placeholder 4">
            <a:extLst>
              <a:ext uri="{FF2B5EF4-FFF2-40B4-BE49-F238E27FC236}">
                <a16:creationId xmlns:a16="http://schemas.microsoft.com/office/drawing/2014/main" id="{3FC4A54D-C9A7-564B-8E07-1CA096C4BF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08E34B-5858-A24C-93F8-C9E692ABFE18}"/>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35872328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BDA818-2BAC-6044-83CC-891CD59234D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4B0B434-1DDE-6D43-A6DF-BF2E14DC08A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040891F-0735-CD49-9A61-59FDF95A9E53}"/>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5" name="Footer Placeholder 4">
            <a:extLst>
              <a:ext uri="{FF2B5EF4-FFF2-40B4-BE49-F238E27FC236}">
                <a16:creationId xmlns:a16="http://schemas.microsoft.com/office/drawing/2014/main" id="{EA17CAF5-7ED1-8543-B5F4-F325508D75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9CD2CD-A36B-074D-9169-4C730D2EC760}"/>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34425678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B8580B-0D3C-3D48-A359-97121C58F0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D77B92F-39F1-4141-BE78-D01B394622D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813A555-01C8-E947-993B-48513A24740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1CE0B45-F071-9943-AD35-C1097E108187}"/>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6" name="Footer Placeholder 5">
            <a:extLst>
              <a:ext uri="{FF2B5EF4-FFF2-40B4-BE49-F238E27FC236}">
                <a16:creationId xmlns:a16="http://schemas.microsoft.com/office/drawing/2014/main" id="{AFF17F34-4B88-2C4C-9809-AE9D1EC7F8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B6F2081-E8E3-B84A-8ECA-4F4DA7A49B00}"/>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16841078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09FCA7-A784-3E44-A597-C497006C251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F32A08C-70E3-EF4B-A017-6C7022D4D12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B9DA9C8-8B83-0A4D-B8B9-E836C2CF0D0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EEA87A4-BCB9-5944-BAC1-A7589489EF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66DECF9-A20E-1E4D-8024-A92D79A8AF0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397C13C-4AAA-F641-8C83-9B436269EED1}"/>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8" name="Footer Placeholder 7">
            <a:extLst>
              <a:ext uri="{FF2B5EF4-FFF2-40B4-BE49-F238E27FC236}">
                <a16:creationId xmlns:a16="http://schemas.microsoft.com/office/drawing/2014/main" id="{74E55FFC-7618-A14A-A66A-A9D6643361A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35379E0-C476-274F-A63E-FAE2228C8DB4}"/>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36216446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9E8E26-90DD-D54B-8D71-E24989C8B68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3CECBDD-8D28-CD41-BBCA-18F68D5E39E1}"/>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4" name="Footer Placeholder 3">
            <a:extLst>
              <a:ext uri="{FF2B5EF4-FFF2-40B4-BE49-F238E27FC236}">
                <a16:creationId xmlns:a16="http://schemas.microsoft.com/office/drawing/2014/main" id="{53CC08E1-DEDD-564B-9451-04EC89A20EC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3E286A8-21B9-334B-AA51-3D589E613E67}"/>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42941078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C9DCA45-EDE0-B349-A2CC-6D98415386AC}"/>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3" name="Footer Placeholder 2">
            <a:extLst>
              <a:ext uri="{FF2B5EF4-FFF2-40B4-BE49-F238E27FC236}">
                <a16:creationId xmlns:a16="http://schemas.microsoft.com/office/drawing/2014/main" id="{67B2369A-7253-5B45-BEFA-BE35BE3B011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246087C-912A-8D4C-9B81-BFA66314640C}"/>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33972195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E6DEC8-C932-514F-AB48-482419C8110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EE88559-4AD3-584F-9B98-BC289F1BC23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3EA8CCD-15A2-F048-9BFF-D963D01A7D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3CC8A09-ABA2-B54B-8C27-53A460D5AD6F}"/>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6" name="Footer Placeholder 5">
            <a:extLst>
              <a:ext uri="{FF2B5EF4-FFF2-40B4-BE49-F238E27FC236}">
                <a16:creationId xmlns:a16="http://schemas.microsoft.com/office/drawing/2014/main" id="{91CAA7E6-0E39-1C4D-991A-927945DFD0B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FB66281-7200-7747-B25B-0455D4E6042D}"/>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19907642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137D74-0622-AB4A-8266-0F4C12D96A2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465D44A-5DA7-0641-BE33-727A58D89D6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5125647-9A9F-0E4B-A05D-968C0DBC1B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9E360C2-54C3-1B47-9D29-FDDDFC513066}"/>
              </a:ext>
            </a:extLst>
          </p:cNvPr>
          <p:cNvSpPr>
            <a:spLocks noGrp="1"/>
          </p:cNvSpPr>
          <p:nvPr>
            <p:ph type="dt" sz="half" idx="10"/>
          </p:nvPr>
        </p:nvSpPr>
        <p:spPr/>
        <p:txBody>
          <a:bodyPr/>
          <a:lstStyle/>
          <a:p>
            <a:fld id="{8C9F130B-995B-0643-835C-F27EA038AC54}" type="datetimeFigureOut">
              <a:rPr lang="en-US" smtClean="0"/>
              <a:t>3/23/2021</a:t>
            </a:fld>
            <a:endParaRPr lang="en-US"/>
          </a:p>
        </p:txBody>
      </p:sp>
      <p:sp>
        <p:nvSpPr>
          <p:cNvPr id="6" name="Footer Placeholder 5">
            <a:extLst>
              <a:ext uri="{FF2B5EF4-FFF2-40B4-BE49-F238E27FC236}">
                <a16:creationId xmlns:a16="http://schemas.microsoft.com/office/drawing/2014/main" id="{3181BB6E-2458-0C49-8903-BC327834E79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A64BB6-433D-9840-BA98-018482711907}"/>
              </a:ext>
            </a:extLst>
          </p:cNvPr>
          <p:cNvSpPr>
            <a:spLocks noGrp="1"/>
          </p:cNvSpPr>
          <p:nvPr>
            <p:ph type="sldNum" sz="quarter" idx="12"/>
          </p:nvPr>
        </p:nvSpPr>
        <p:spPr/>
        <p:txBody>
          <a:bodyPr/>
          <a:lstStyle/>
          <a:p>
            <a:fld id="{28D54F79-2A15-7844-B0EC-F30697772152}" type="slidenum">
              <a:rPr lang="en-US" smtClean="0"/>
              <a:t>‹Nr.›</a:t>
            </a:fld>
            <a:endParaRPr lang="en-US"/>
          </a:p>
        </p:txBody>
      </p:sp>
    </p:spTree>
    <p:extLst>
      <p:ext uri="{BB962C8B-B14F-4D97-AF65-F5344CB8AC3E}">
        <p14:creationId xmlns:p14="http://schemas.microsoft.com/office/powerpoint/2010/main" val="1069005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EFA7DD9-F447-B149-8B8A-511CE56E9D1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03ECAB1-DFE4-A34A-9A22-D59415D4598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4730EF-B9C4-A843-B13C-DE8A05C7348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C9F130B-995B-0643-835C-F27EA038AC54}" type="datetimeFigureOut">
              <a:rPr lang="en-US" smtClean="0"/>
              <a:t>3/23/2021</a:t>
            </a:fld>
            <a:endParaRPr lang="en-US"/>
          </a:p>
        </p:txBody>
      </p:sp>
      <p:sp>
        <p:nvSpPr>
          <p:cNvPr id="5" name="Footer Placeholder 4">
            <a:extLst>
              <a:ext uri="{FF2B5EF4-FFF2-40B4-BE49-F238E27FC236}">
                <a16:creationId xmlns:a16="http://schemas.microsoft.com/office/drawing/2014/main" id="{7669D5F1-9E0F-FD4C-B341-E81086D3080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8143B54-6949-024F-836A-B0BD5AE2A8B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8D54F79-2A15-7844-B0EC-F30697772152}" type="slidenum">
              <a:rPr lang="en-US" smtClean="0"/>
              <a:t>‹Nr.›</a:t>
            </a:fld>
            <a:endParaRPr lang="en-US"/>
          </a:p>
        </p:txBody>
      </p:sp>
    </p:spTree>
    <p:extLst>
      <p:ext uri="{BB962C8B-B14F-4D97-AF65-F5344CB8AC3E}">
        <p14:creationId xmlns:p14="http://schemas.microsoft.com/office/powerpoint/2010/main" val="10799687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CCBEDF2-005E-5247-AA7C-7895AADB51D2}"/>
              </a:ext>
            </a:extLst>
          </p:cNvPr>
          <p:cNvSpPr txBox="1"/>
          <p:nvPr/>
        </p:nvSpPr>
        <p:spPr>
          <a:xfrm>
            <a:off x="0" y="77419"/>
            <a:ext cx="12192000" cy="1384995"/>
          </a:xfrm>
          <a:prstGeom prst="rect">
            <a:avLst/>
          </a:prstGeom>
          <a:noFill/>
        </p:spPr>
        <p:txBody>
          <a:bodyPr wrap="square" rtlCol="0">
            <a:spAutoFit/>
          </a:bodyPr>
          <a:lstStyle/>
          <a:p>
            <a:r>
              <a:rPr lang="en-US" sz="1200" i="1"/>
              <a:t>Supplementary file 6: </a:t>
            </a:r>
            <a:r>
              <a:rPr lang="en-US" sz="1200"/>
              <a:t>Kernel density plot of the coefficient of variation (CV) for each feature (= ASV) of the ScoSa distance and the ScoSa salmon production phase dataset. To infer the coefficient of variation (CV) for each feature of the ScoSa data set, the cv function of the </a:t>
            </a:r>
            <a:r>
              <a:rPr lang="en-US" sz="1200" i="1"/>
              <a:t>EnvStats</a:t>
            </a:r>
            <a:r>
              <a:rPr lang="en-US" sz="1200"/>
              <a:t> package was used. The coefficient of variation measures how widely scattered the distribution is relative to the size of the mean. The CV was calculated using samples grouped by "sampling season" or " salmon production phase” respectively. The respective CVs per group were then plotted against each other in a multiple density plot. The </a:t>
            </a:r>
            <a:r>
              <a:rPr lang="en-US" sz="1200" dirty="0"/>
              <a:t>density plot shows the kernel density estimations per group. The construction of probability density functions is based on the idea that the area between the function and the x-axis (the integral) from a point a to a point b corresponds to the probability of obtaining a value between a and b. The dashed lines indicate the CV group </a:t>
            </a:r>
            <a:r>
              <a:rPr lang="en-US" sz="1200"/>
              <a:t>mean (station</a:t>
            </a:r>
            <a:r>
              <a:rPr lang="en-US" sz="1200" dirty="0"/>
              <a:t>= 1.23</a:t>
            </a:r>
            <a:r>
              <a:rPr lang="en-US" sz="1200"/>
              <a:t>, salmon production phase = </a:t>
            </a:r>
            <a:r>
              <a:rPr lang="en-US" sz="1200" dirty="0"/>
              <a:t>1.53). Thus, when </a:t>
            </a:r>
            <a:r>
              <a:rPr lang="en-US" sz="1200" dirty="0" err="1"/>
              <a:t>downsampling</a:t>
            </a:r>
            <a:r>
              <a:rPr lang="en-US" sz="1200" dirty="0"/>
              <a:t> </a:t>
            </a:r>
            <a:r>
              <a:rPr lang="en-US" sz="1200"/>
              <a:t>the ScoSa salmon production phase </a:t>
            </a:r>
            <a:r>
              <a:rPr lang="en-US" sz="1200" dirty="0"/>
              <a:t>dataset, it can be expected that the removal of a substantial number of ASVs from the full dataset still leaves more informative features with a high CV than is the case for </a:t>
            </a:r>
            <a:r>
              <a:rPr lang="en-US" sz="1200"/>
              <a:t>the ScoSa </a:t>
            </a:r>
            <a:r>
              <a:rPr lang="en-US" sz="1200" dirty="0"/>
              <a:t>distance dataset. </a:t>
            </a:r>
          </a:p>
        </p:txBody>
      </p:sp>
      <p:pic>
        <p:nvPicPr>
          <p:cNvPr id="7" name="Grafik 6">
            <a:extLst>
              <a:ext uri="{FF2B5EF4-FFF2-40B4-BE49-F238E27FC236}">
                <a16:creationId xmlns:a16="http://schemas.microsoft.com/office/drawing/2014/main" id="{159DC5BB-ECD5-4BAA-92EF-3979AEA99EA3}"/>
              </a:ext>
            </a:extLst>
          </p:cNvPr>
          <p:cNvPicPr>
            <a:picLocks noChangeAspect="1"/>
          </p:cNvPicPr>
          <p:nvPr/>
        </p:nvPicPr>
        <p:blipFill>
          <a:blip r:embed="rId3"/>
          <a:stretch>
            <a:fillRect/>
          </a:stretch>
        </p:blipFill>
        <p:spPr>
          <a:xfrm>
            <a:off x="2340900" y="1561804"/>
            <a:ext cx="7903931" cy="5218777"/>
          </a:xfrm>
          <a:prstGeom prst="rect">
            <a:avLst/>
          </a:prstGeom>
        </p:spPr>
      </p:pic>
    </p:spTree>
    <p:extLst>
      <p:ext uri="{BB962C8B-B14F-4D97-AF65-F5344CB8AC3E}">
        <p14:creationId xmlns:p14="http://schemas.microsoft.com/office/powerpoint/2010/main" val="15348744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40</Words>
  <Application>Microsoft Office PowerPoint</Application>
  <PresentationFormat>Breitbild</PresentationFormat>
  <Paragraphs>2</Paragraphs>
  <Slides>1</Slides>
  <Notes>1</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 Theme</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rsten Stoeck</dc:creator>
  <cp:lastModifiedBy>Verena Dully</cp:lastModifiedBy>
  <cp:revision>9</cp:revision>
  <dcterms:created xsi:type="dcterms:W3CDTF">2020-12-15T15:56:00Z</dcterms:created>
  <dcterms:modified xsi:type="dcterms:W3CDTF">2021-03-23T12:52:34Z</dcterms:modified>
</cp:coreProperties>
</file>